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46875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8B671-5AF8-47E4-8551-8DD85D1742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A9D72-2095-4AEC-9314-C34CA45E3E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C44CC-5675-4B07-BA30-509F0A25E4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0F3FC-52CB-4B38-ADD6-3355B1371A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979FC-14F3-43C6-8964-7D415D6E79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7ECD3-2C3D-402F-B441-C689BEBDCE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B6631-127D-4F85-B112-7AAB441BB9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77284-6310-4A2A-AD08-EF322626B6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77650-9A0C-4CA9-9443-EC0917E2B3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E4205-E120-4B22-8C99-7407984E42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347B2-3B0A-4C4C-9C65-2CC47846D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07EC3-7617-4DAA-B248-82DB150F03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58EA9A-1728-4299-BDDD-96F414E993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00000" y="765000"/>
            <a:ext cx="7415280" cy="4905360"/>
            <a:chOff x="900000" y="765000"/>
            <a:chExt cx="7415280" cy="4905360"/>
          </a:xfrm>
        </p:grpSpPr>
        <p:graphicFrame>
          <p:nvGraphicFramePr>
            <p:cNvPr id="42" name=""/>
            <p:cNvGraphicFramePr/>
            <p:nvPr/>
          </p:nvGraphicFramePr>
          <p:xfrm>
            <a:off x="1509840" y="795240"/>
            <a:ext cx="6805440" cy="39513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509840" y="795240"/>
                      <a:ext cx="6805440" cy="3951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900000" y="765000"/>
            <a:ext cx="6905520" cy="490536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900000" y="765000"/>
                      <a:ext cx="6905520" cy="4905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46" name=""/>
          <p:cNvSpPr/>
          <p:nvPr/>
        </p:nvSpPr>
        <p:spPr>
          <a:xfrm>
            <a:off x="4102920" y="5589720"/>
            <a:ext cx="133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Zs class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0800000">
            <a:off x="541440" y="1556640"/>
            <a:ext cx="454680" cy="194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requency (ba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0800000">
            <a:off x="8102160" y="1590480"/>
            <a:ext cx="454680" cy="212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Precision % (lin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834080" y="1405080"/>
            <a:ext cx="144360" cy="142560"/>
          </a:xfrm>
          <a:prstGeom prst="rect">
            <a:avLst/>
          </a:prstGeom>
          <a:solidFill>
            <a:srgbClr val="7510f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694480" y="1405080"/>
            <a:ext cx="144360" cy="142560"/>
          </a:xfrm>
          <a:prstGeom prst="rect">
            <a:avLst/>
          </a:prstGeom>
          <a:solidFill>
            <a:srgbClr val="ef5d0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834080" y="1765440"/>
            <a:ext cx="144360" cy="1425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694480" y="1765440"/>
            <a:ext cx="144360" cy="142560"/>
          </a:xfrm>
          <a:prstGeom prst="rect">
            <a:avLst/>
          </a:prstGeom>
          <a:solidFill>
            <a:srgbClr val="fed5c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562920" y="1317600"/>
            <a:ext cx="96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True posi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531600" y="1641600"/>
            <a:ext cx="106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alse  posi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505400" y="1044720"/>
            <a:ext cx="75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Origin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366880" y="1044720"/>
            <a:ext cx="92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No hom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"/>
          <p:cNvGrpSpPr/>
          <p:nvPr/>
        </p:nvGrpSpPr>
        <p:grpSpPr>
          <a:xfrm>
            <a:off x="4716360" y="2060640"/>
            <a:ext cx="432000" cy="144360"/>
            <a:chOff x="4716360" y="2060640"/>
            <a:chExt cx="432000" cy="144360"/>
          </a:xfrm>
        </p:grpSpPr>
        <p:sp>
          <p:nvSpPr>
            <p:cNvPr id="58" name=""/>
            <p:cNvSpPr/>
            <p:nvPr/>
          </p:nvSpPr>
          <p:spPr>
            <a:xfrm>
              <a:off x="4716360" y="2131920"/>
              <a:ext cx="432000" cy="0"/>
            </a:xfrm>
            <a:prstGeom prst="line">
              <a:avLst/>
            </a:prstGeom>
            <a:ln w="2844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848120" y="2060640"/>
              <a:ext cx="144360" cy="144360"/>
            </a:xfrm>
            <a:prstGeom prst="diamond">
              <a:avLst/>
            </a:prstGeom>
            <a:solidFill>
              <a:srgbClr val="333399"/>
            </a:solidFill>
            <a:ln w="936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3630960" y="2001960"/>
            <a:ext cx="86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reci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"/>
          <p:cNvGrpSpPr/>
          <p:nvPr/>
        </p:nvGrpSpPr>
        <p:grpSpPr>
          <a:xfrm>
            <a:off x="5580000" y="2104920"/>
            <a:ext cx="432000" cy="100080"/>
            <a:chOff x="5580000" y="2104920"/>
            <a:chExt cx="432000" cy="100080"/>
          </a:xfrm>
        </p:grpSpPr>
        <p:sp>
          <p:nvSpPr>
            <p:cNvPr id="62" name=""/>
            <p:cNvSpPr/>
            <p:nvPr/>
          </p:nvSpPr>
          <p:spPr>
            <a:xfrm>
              <a:off x="5580000" y="2147760"/>
              <a:ext cx="432000" cy="0"/>
            </a:xfrm>
            <a:prstGeom prst="line">
              <a:avLst/>
            </a:prstGeom>
            <a:ln w="28440">
              <a:solidFill>
                <a:srgbClr val="fd3f0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738760" y="2104920"/>
              <a:ext cx="111240" cy="100080"/>
            </a:xfrm>
            <a:prstGeom prst="rect">
              <a:avLst/>
            </a:prstGeom>
            <a:solidFill>
              <a:srgbClr val="ef5d03"/>
            </a:solidFill>
            <a:ln w="9360">
              <a:solidFill>
                <a:srgbClr val="ef5d0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3207600" y="63086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8T17:52:11Z</dcterms:created>
  <dc:creator>ucbcja0</dc:creator>
  <dc:description/>
  <dc:language>en-US</dc:language>
  <cp:lastModifiedBy>ucbcja0</cp:lastModifiedBy>
  <dcterms:modified xsi:type="dcterms:W3CDTF">2007-06-08T15:05:28Z</dcterms:modified>
  <cp:revision>10</cp:revision>
  <dc:subject/>
  <dc:title>Slide 1</dc:title>
</cp:coreProperties>
</file>